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0" r:id="rId2"/>
  </p:sldIdLst>
  <p:sldSz cx="6264275" cy="8423275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202B0CA-FC54-4496-8BCA-5EF66A818D29}" styleName="Dark Style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E8034E78-7F5D-4C2E-B375-FC64B27BC917}" styleName="Dark Style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0505E3EF-67EA-436B-97B2-0124C06EBD24}" styleName="Medium Style 4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78" autoAdjust="0"/>
    <p:restoredTop sz="94660"/>
  </p:normalViewPr>
  <p:slideViewPr>
    <p:cSldViewPr snapToGrid="0">
      <p:cViewPr varScale="1">
        <p:scale>
          <a:sx n="64" d="100"/>
          <a:sy n="64" d="100"/>
        </p:scale>
        <p:origin x="177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9821" y="1378532"/>
            <a:ext cx="5324634" cy="2932548"/>
          </a:xfrm>
        </p:spPr>
        <p:txBody>
          <a:bodyPr anchor="b"/>
          <a:lstStyle>
            <a:lvl1pPr algn="ctr">
              <a:defRPr sz="4111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83035" y="4424170"/>
            <a:ext cx="4698206" cy="2033674"/>
          </a:xfrm>
        </p:spPr>
        <p:txBody>
          <a:bodyPr/>
          <a:lstStyle>
            <a:lvl1pPr marL="0" indent="0" algn="ctr">
              <a:buNone/>
              <a:defRPr sz="1644"/>
            </a:lvl1pPr>
            <a:lvl2pPr marL="313228" indent="0" algn="ctr">
              <a:buNone/>
              <a:defRPr sz="1370"/>
            </a:lvl2pPr>
            <a:lvl3pPr marL="626455" indent="0" algn="ctr">
              <a:buNone/>
              <a:defRPr sz="1233"/>
            </a:lvl3pPr>
            <a:lvl4pPr marL="939683" indent="0" algn="ctr">
              <a:buNone/>
              <a:defRPr sz="1096"/>
            </a:lvl4pPr>
            <a:lvl5pPr marL="1252911" indent="0" algn="ctr">
              <a:buNone/>
              <a:defRPr sz="1096"/>
            </a:lvl5pPr>
            <a:lvl6pPr marL="1566139" indent="0" algn="ctr">
              <a:buNone/>
              <a:defRPr sz="1096"/>
            </a:lvl6pPr>
            <a:lvl7pPr marL="1879366" indent="0" algn="ctr">
              <a:buNone/>
              <a:defRPr sz="1096"/>
            </a:lvl7pPr>
            <a:lvl8pPr marL="2192594" indent="0" algn="ctr">
              <a:buNone/>
              <a:defRPr sz="1096"/>
            </a:lvl8pPr>
            <a:lvl9pPr marL="2505822" indent="0" algn="ctr">
              <a:buNone/>
              <a:defRPr sz="1096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2D0B8-3730-436A-95A9-C0FE41A62BAC}" type="datetimeFigureOut">
              <a:rPr lang="en-US" smtClean="0"/>
              <a:t>2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82290-0D16-43A9-B093-FE52023532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09720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2D0B8-3730-436A-95A9-C0FE41A62BAC}" type="datetimeFigureOut">
              <a:rPr lang="en-US" smtClean="0"/>
              <a:t>2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82290-0D16-43A9-B093-FE52023532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95577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82872" y="448462"/>
            <a:ext cx="1350734" cy="713833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30669" y="448462"/>
            <a:ext cx="3973899" cy="7138336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2D0B8-3730-436A-95A9-C0FE41A62BAC}" type="datetimeFigureOut">
              <a:rPr lang="en-US" smtClean="0"/>
              <a:t>2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82290-0D16-43A9-B093-FE52023532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06889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2D0B8-3730-436A-95A9-C0FE41A62BAC}" type="datetimeFigureOut">
              <a:rPr lang="en-US" smtClean="0"/>
              <a:t>2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82290-0D16-43A9-B093-FE52023532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06793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7407" y="2099972"/>
            <a:ext cx="5402937" cy="3503848"/>
          </a:xfrm>
        </p:spPr>
        <p:txBody>
          <a:bodyPr anchor="b"/>
          <a:lstStyle>
            <a:lvl1pPr>
              <a:defRPr sz="4111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7407" y="5636967"/>
            <a:ext cx="5402937" cy="1842591"/>
          </a:xfrm>
        </p:spPr>
        <p:txBody>
          <a:bodyPr/>
          <a:lstStyle>
            <a:lvl1pPr marL="0" indent="0">
              <a:buNone/>
              <a:defRPr sz="1644">
                <a:solidFill>
                  <a:schemeClr val="tx1"/>
                </a:solidFill>
              </a:defRPr>
            </a:lvl1pPr>
            <a:lvl2pPr marL="313228" indent="0">
              <a:buNone/>
              <a:defRPr sz="1370">
                <a:solidFill>
                  <a:schemeClr val="tx1">
                    <a:tint val="75000"/>
                  </a:schemeClr>
                </a:solidFill>
              </a:defRPr>
            </a:lvl2pPr>
            <a:lvl3pPr marL="626455" indent="0">
              <a:buNone/>
              <a:defRPr sz="1233">
                <a:solidFill>
                  <a:schemeClr val="tx1">
                    <a:tint val="75000"/>
                  </a:schemeClr>
                </a:solidFill>
              </a:defRPr>
            </a:lvl3pPr>
            <a:lvl4pPr marL="939683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4pPr>
            <a:lvl5pPr marL="1252911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5pPr>
            <a:lvl6pPr marL="1566139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6pPr>
            <a:lvl7pPr marL="1879366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7pPr>
            <a:lvl8pPr marL="2192594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8pPr>
            <a:lvl9pPr marL="2505822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2D0B8-3730-436A-95A9-C0FE41A62BAC}" type="datetimeFigureOut">
              <a:rPr lang="en-US" smtClean="0"/>
              <a:t>2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82290-0D16-43A9-B093-FE52023532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62042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30669" y="2242307"/>
            <a:ext cx="2662317" cy="5344491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71289" y="2242307"/>
            <a:ext cx="2662317" cy="5344491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2D0B8-3730-436A-95A9-C0FE41A62BAC}" type="datetimeFigureOut">
              <a:rPr lang="en-US" smtClean="0"/>
              <a:t>2/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82290-0D16-43A9-B093-FE52023532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92744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448463"/>
            <a:ext cx="5402937" cy="162811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1485" y="2064873"/>
            <a:ext cx="2650082" cy="1011962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8" indent="0">
              <a:buNone/>
              <a:defRPr sz="1370" b="1"/>
            </a:lvl2pPr>
            <a:lvl3pPr marL="626455" indent="0">
              <a:buNone/>
              <a:defRPr sz="1233" b="1"/>
            </a:lvl3pPr>
            <a:lvl4pPr marL="939683" indent="0">
              <a:buNone/>
              <a:defRPr sz="1096" b="1"/>
            </a:lvl4pPr>
            <a:lvl5pPr marL="1252911" indent="0">
              <a:buNone/>
              <a:defRPr sz="1096" b="1"/>
            </a:lvl5pPr>
            <a:lvl6pPr marL="1566139" indent="0">
              <a:buNone/>
              <a:defRPr sz="1096" b="1"/>
            </a:lvl6pPr>
            <a:lvl7pPr marL="1879366" indent="0">
              <a:buNone/>
              <a:defRPr sz="1096" b="1"/>
            </a:lvl7pPr>
            <a:lvl8pPr marL="2192594" indent="0">
              <a:buNone/>
              <a:defRPr sz="1096" b="1"/>
            </a:lvl8pPr>
            <a:lvl9pPr marL="2505822" indent="0">
              <a:buNone/>
              <a:defRPr sz="1096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1485" y="3076835"/>
            <a:ext cx="2650082" cy="4525561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71289" y="2064873"/>
            <a:ext cx="2663133" cy="1011962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8" indent="0">
              <a:buNone/>
              <a:defRPr sz="1370" b="1"/>
            </a:lvl2pPr>
            <a:lvl3pPr marL="626455" indent="0">
              <a:buNone/>
              <a:defRPr sz="1233" b="1"/>
            </a:lvl3pPr>
            <a:lvl4pPr marL="939683" indent="0">
              <a:buNone/>
              <a:defRPr sz="1096" b="1"/>
            </a:lvl4pPr>
            <a:lvl5pPr marL="1252911" indent="0">
              <a:buNone/>
              <a:defRPr sz="1096" b="1"/>
            </a:lvl5pPr>
            <a:lvl6pPr marL="1566139" indent="0">
              <a:buNone/>
              <a:defRPr sz="1096" b="1"/>
            </a:lvl6pPr>
            <a:lvl7pPr marL="1879366" indent="0">
              <a:buNone/>
              <a:defRPr sz="1096" b="1"/>
            </a:lvl7pPr>
            <a:lvl8pPr marL="2192594" indent="0">
              <a:buNone/>
              <a:defRPr sz="1096" b="1"/>
            </a:lvl8pPr>
            <a:lvl9pPr marL="2505822" indent="0">
              <a:buNone/>
              <a:defRPr sz="1096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71289" y="3076835"/>
            <a:ext cx="2663133" cy="4525561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2D0B8-3730-436A-95A9-C0FE41A62BAC}" type="datetimeFigureOut">
              <a:rPr lang="en-US" smtClean="0"/>
              <a:t>2/9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82290-0D16-43A9-B093-FE52023532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39906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2D0B8-3730-436A-95A9-C0FE41A62BAC}" type="datetimeFigureOut">
              <a:rPr lang="en-US" smtClean="0"/>
              <a:t>2/9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82290-0D16-43A9-B093-FE52023532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54921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2D0B8-3730-436A-95A9-C0FE41A62BAC}" type="datetimeFigureOut">
              <a:rPr lang="en-US" smtClean="0"/>
              <a:t>2/9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82290-0D16-43A9-B093-FE52023532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73816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561552"/>
            <a:ext cx="2020392" cy="1965431"/>
          </a:xfrm>
        </p:spPr>
        <p:txBody>
          <a:bodyPr anchor="b"/>
          <a:lstStyle>
            <a:lvl1pPr>
              <a:defRPr sz="2192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63133" y="1212797"/>
            <a:ext cx="3171289" cy="5985985"/>
          </a:xfrm>
        </p:spPr>
        <p:txBody>
          <a:bodyPr/>
          <a:lstStyle>
            <a:lvl1pPr>
              <a:defRPr sz="2192"/>
            </a:lvl1pPr>
            <a:lvl2pPr>
              <a:defRPr sz="1918"/>
            </a:lvl2pPr>
            <a:lvl3pPr>
              <a:defRPr sz="1644"/>
            </a:lvl3pPr>
            <a:lvl4pPr>
              <a:defRPr sz="1370"/>
            </a:lvl4pPr>
            <a:lvl5pPr>
              <a:defRPr sz="1370"/>
            </a:lvl5pPr>
            <a:lvl6pPr>
              <a:defRPr sz="1370"/>
            </a:lvl6pPr>
            <a:lvl7pPr>
              <a:defRPr sz="1370"/>
            </a:lvl7pPr>
            <a:lvl8pPr>
              <a:defRPr sz="1370"/>
            </a:lvl8pPr>
            <a:lvl9pPr>
              <a:defRPr sz="137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1485" y="2526982"/>
            <a:ext cx="2020392" cy="4681548"/>
          </a:xfrm>
        </p:spPr>
        <p:txBody>
          <a:bodyPr/>
          <a:lstStyle>
            <a:lvl1pPr marL="0" indent="0">
              <a:buNone/>
              <a:defRPr sz="1096"/>
            </a:lvl1pPr>
            <a:lvl2pPr marL="313228" indent="0">
              <a:buNone/>
              <a:defRPr sz="959"/>
            </a:lvl2pPr>
            <a:lvl3pPr marL="626455" indent="0">
              <a:buNone/>
              <a:defRPr sz="822"/>
            </a:lvl3pPr>
            <a:lvl4pPr marL="939683" indent="0">
              <a:buNone/>
              <a:defRPr sz="685"/>
            </a:lvl4pPr>
            <a:lvl5pPr marL="1252911" indent="0">
              <a:buNone/>
              <a:defRPr sz="685"/>
            </a:lvl5pPr>
            <a:lvl6pPr marL="1566139" indent="0">
              <a:buNone/>
              <a:defRPr sz="685"/>
            </a:lvl6pPr>
            <a:lvl7pPr marL="1879366" indent="0">
              <a:buNone/>
              <a:defRPr sz="685"/>
            </a:lvl7pPr>
            <a:lvl8pPr marL="2192594" indent="0">
              <a:buNone/>
              <a:defRPr sz="685"/>
            </a:lvl8pPr>
            <a:lvl9pPr marL="2505822" indent="0">
              <a:buNone/>
              <a:defRPr sz="685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2D0B8-3730-436A-95A9-C0FE41A62BAC}" type="datetimeFigureOut">
              <a:rPr lang="en-US" smtClean="0"/>
              <a:t>2/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82290-0D16-43A9-B093-FE52023532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74012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561552"/>
            <a:ext cx="2020392" cy="1965431"/>
          </a:xfrm>
        </p:spPr>
        <p:txBody>
          <a:bodyPr anchor="b"/>
          <a:lstStyle>
            <a:lvl1pPr>
              <a:defRPr sz="2192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63133" y="1212797"/>
            <a:ext cx="3171289" cy="5985985"/>
          </a:xfrm>
        </p:spPr>
        <p:txBody>
          <a:bodyPr anchor="t"/>
          <a:lstStyle>
            <a:lvl1pPr marL="0" indent="0">
              <a:buNone/>
              <a:defRPr sz="2192"/>
            </a:lvl1pPr>
            <a:lvl2pPr marL="313228" indent="0">
              <a:buNone/>
              <a:defRPr sz="1918"/>
            </a:lvl2pPr>
            <a:lvl3pPr marL="626455" indent="0">
              <a:buNone/>
              <a:defRPr sz="1644"/>
            </a:lvl3pPr>
            <a:lvl4pPr marL="939683" indent="0">
              <a:buNone/>
              <a:defRPr sz="1370"/>
            </a:lvl4pPr>
            <a:lvl5pPr marL="1252911" indent="0">
              <a:buNone/>
              <a:defRPr sz="1370"/>
            </a:lvl5pPr>
            <a:lvl6pPr marL="1566139" indent="0">
              <a:buNone/>
              <a:defRPr sz="1370"/>
            </a:lvl6pPr>
            <a:lvl7pPr marL="1879366" indent="0">
              <a:buNone/>
              <a:defRPr sz="1370"/>
            </a:lvl7pPr>
            <a:lvl8pPr marL="2192594" indent="0">
              <a:buNone/>
              <a:defRPr sz="1370"/>
            </a:lvl8pPr>
            <a:lvl9pPr marL="2505822" indent="0">
              <a:buNone/>
              <a:defRPr sz="137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1485" y="2526982"/>
            <a:ext cx="2020392" cy="4681548"/>
          </a:xfrm>
        </p:spPr>
        <p:txBody>
          <a:bodyPr/>
          <a:lstStyle>
            <a:lvl1pPr marL="0" indent="0">
              <a:buNone/>
              <a:defRPr sz="1096"/>
            </a:lvl1pPr>
            <a:lvl2pPr marL="313228" indent="0">
              <a:buNone/>
              <a:defRPr sz="959"/>
            </a:lvl2pPr>
            <a:lvl3pPr marL="626455" indent="0">
              <a:buNone/>
              <a:defRPr sz="822"/>
            </a:lvl3pPr>
            <a:lvl4pPr marL="939683" indent="0">
              <a:buNone/>
              <a:defRPr sz="685"/>
            </a:lvl4pPr>
            <a:lvl5pPr marL="1252911" indent="0">
              <a:buNone/>
              <a:defRPr sz="685"/>
            </a:lvl5pPr>
            <a:lvl6pPr marL="1566139" indent="0">
              <a:buNone/>
              <a:defRPr sz="685"/>
            </a:lvl6pPr>
            <a:lvl7pPr marL="1879366" indent="0">
              <a:buNone/>
              <a:defRPr sz="685"/>
            </a:lvl7pPr>
            <a:lvl8pPr marL="2192594" indent="0">
              <a:buNone/>
              <a:defRPr sz="685"/>
            </a:lvl8pPr>
            <a:lvl9pPr marL="2505822" indent="0">
              <a:buNone/>
              <a:defRPr sz="685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2D0B8-3730-436A-95A9-C0FE41A62BAC}" type="datetimeFigureOut">
              <a:rPr lang="en-US" smtClean="0"/>
              <a:t>2/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82290-0D16-43A9-B093-FE52023532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8659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30669" y="448463"/>
            <a:ext cx="5402937" cy="162811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0669" y="2242307"/>
            <a:ext cx="5402937" cy="53444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30669" y="7807130"/>
            <a:ext cx="1409462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72D0B8-3730-436A-95A9-C0FE41A62BAC}" type="datetimeFigureOut">
              <a:rPr lang="en-US" smtClean="0"/>
              <a:t>2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75041" y="7807130"/>
            <a:ext cx="2114193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24144" y="7807130"/>
            <a:ext cx="1409462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382290-0D16-43A9-B093-FE52023532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85031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26455" rtl="0" eaLnBrk="1" latinLnBrk="0" hangingPunct="1">
        <a:lnSpc>
          <a:spcPct val="90000"/>
        </a:lnSpc>
        <a:spcBef>
          <a:spcPct val="0"/>
        </a:spcBef>
        <a:buNone/>
        <a:defRPr sz="301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6614" indent="-156614" algn="l" defTabSz="626455" rtl="0" eaLnBrk="1" latinLnBrk="0" hangingPunct="1">
        <a:lnSpc>
          <a:spcPct val="90000"/>
        </a:lnSpc>
        <a:spcBef>
          <a:spcPts val="685"/>
        </a:spcBef>
        <a:buFont typeface="Arial" panose="020B0604020202020204" pitchFamily="34" charset="0"/>
        <a:buChar char="•"/>
        <a:defRPr sz="1918" kern="1200">
          <a:solidFill>
            <a:schemeClr val="tx1"/>
          </a:solidFill>
          <a:latin typeface="+mn-lt"/>
          <a:ea typeface="+mn-ea"/>
          <a:cs typeface="+mn-cs"/>
        </a:defRPr>
      </a:lvl1pPr>
      <a:lvl2pPr marL="469842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644" kern="1200">
          <a:solidFill>
            <a:schemeClr val="tx1"/>
          </a:solidFill>
          <a:latin typeface="+mn-lt"/>
          <a:ea typeface="+mn-ea"/>
          <a:cs typeface="+mn-cs"/>
        </a:defRPr>
      </a:lvl2pPr>
      <a:lvl3pPr marL="783069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370" kern="1200">
          <a:solidFill>
            <a:schemeClr val="tx1"/>
          </a:solidFill>
          <a:latin typeface="+mn-lt"/>
          <a:ea typeface="+mn-ea"/>
          <a:cs typeface="+mn-cs"/>
        </a:defRPr>
      </a:lvl3pPr>
      <a:lvl4pPr marL="1096297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4pPr>
      <a:lvl5pPr marL="1409525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5pPr>
      <a:lvl6pPr marL="1722752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6pPr>
      <a:lvl7pPr marL="2035980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7pPr>
      <a:lvl8pPr marL="2349208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8pPr>
      <a:lvl9pPr marL="2662436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1pPr>
      <a:lvl2pPr marL="313228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2pPr>
      <a:lvl3pPr marL="626455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3pPr>
      <a:lvl4pPr marL="939683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4pPr>
      <a:lvl5pPr marL="1252911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5pPr>
      <a:lvl6pPr marL="1566139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6pPr>
      <a:lvl7pPr marL="1879366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7pPr>
      <a:lvl8pPr marL="2192594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8pPr>
      <a:lvl9pPr marL="2505822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91031247"/>
              </p:ext>
            </p:extLst>
          </p:nvPr>
        </p:nvGraphicFramePr>
        <p:xfrm>
          <a:off x="178677" y="1866823"/>
          <a:ext cx="5948854" cy="4218345"/>
        </p:xfrm>
        <a:graphic>
          <a:graphicData uri="http://schemas.openxmlformats.org/drawingml/2006/table">
            <a:tbl>
              <a:tblPr firstRow="1" bandRow="1">
                <a:tableStyleId>{D7AC3CCA-C797-4891-BE02-D94E43425B78}</a:tableStyleId>
              </a:tblPr>
              <a:tblGrid>
                <a:gridCol w="1061544">
                  <a:extLst>
                    <a:ext uri="{9D8B030D-6E8A-4147-A177-3AD203B41FA5}">
                      <a16:colId xmlns:a16="http://schemas.microsoft.com/office/drawing/2014/main" val="2129121626"/>
                    </a:ext>
                  </a:extLst>
                </a:gridCol>
                <a:gridCol w="425669">
                  <a:extLst>
                    <a:ext uri="{9D8B030D-6E8A-4147-A177-3AD203B41FA5}">
                      <a16:colId xmlns:a16="http://schemas.microsoft.com/office/drawing/2014/main" val="1172703050"/>
                    </a:ext>
                  </a:extLst>
                </a:gridCol>
                <a:gridCol w="593834">
                  <a:extLst>
                    <a:ext uri="{9D8B030D-6E8A-4147-A177-3AD203B41FA5}">
                      <a16:colId xmlns:a16="http://schemas.microsoft.com/office/drawing/2014/main" val="1715860778"/>
                    </a:ext>
                  </a:extLst>
                </a:gridCol>
                <a:gridCol w="998483">
                  <a:extLst>
                    <a:ext uri="{9D8B030D-6E8A-4147-A177-3AD203B41FA5}">
                      <a16:colId xmlns:a16="http://schemas.microsoft.com/office/drawing/2014/main" val="659083079"/>
                    </a:ext>
                  </a:extLst>
                </a:gridCol>
                <a:gridCol w="904719">
                  <a:extLst>
                    <a:ext uri="{9D8B030D-6E8A-4147-A177-3AD203B41FA5}">
                      <a16:colId xmlns:a16="http://schemas.microsoft.com/office/drawing/2014/main" val="3814215091"/>
                    </a:ext>
                  </a:extLst>
                </a:gridCol>
                <a:gridCol w="882040">
                  <a:extLst>
                    <a:ext uri="{9D8B030D-6E8A-4147-A177-3AD203B41FA5}">
                      <a16:colId xmlns:a16="http://schemas.microsoft.com/office/drawing/2014/main" val="1913291841"/>
                    </a:ext>
                  </a:extLst>
                </a:gridCol>
                <a:gridCol w="1082565">
                  <a:extLst>
                    <a:ext uri="{9D8B030D-6E8A-4147-A177-3AD203B41FA5}">
                      <a16:colId xmlns:a16="http://schemas.microsoft.com/office/drawing/2014/main" val="386224640"/>
                    </a:ext>
                  </a:extLst>
                </a:gridCol>
              </a:tblGrid>
              <a:tr h="313854">
                <a:tc gridSpan="7">
                  <a:txBody>
                    <a:bodyPr/>
                    <a:lstStyle/>
                    <a:p>
                      <a:pPr algn="l"/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pplementary</a:t>
                      </a:r>
                      <a:r>
                        <a:rPr lang="en-US" sz="11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able 1. </a:t>
                      </a:r>
                      <a:r>
                        <a:rPr lang="en-US" sz="1100" b="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ient Demographics</a:t>
                      </a:r>
                      <a:endParaRPr lang="en-US" sz="1100" b="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92253319"/>
                  </a:ext>
                </a:extLst>
              </a:tr>
              <a:tr h="579789">
                <a:tc>
                  <a:txBody>
                    <a:bodyPr/>
                    <a:lstStyle/>
                    <a:p>
                      <a:pPr algn="ctr"/>
                      <a:endParaRPr lang="en-US" sz="11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endParaRPr 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 Male</a:t>
                      </a:r>
                      <a:endParaRPr 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tmortem</a:t>
                      </a:r>
                      <a:r>
                        <a:rPr lang="en-US" sz="1100" b="1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Interval (hours)</a:t>
                      </a:r>
                      <a:endParaRPr 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 of Onset (years)</a:t>
                      </a:r>
                      <a:endParaRPr 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uration (years)</a:t>
                      </a:r>
                      <a:endParaRPr 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 at Death (years)</a:t>
                      </a:r>
                      <a:endParaRPr 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15670632"/>
                  </a:ext>
                </a:extLst>
              </a:tr>
              <a:tr h="558752"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zheimer’s Disease (AD) </a:t>
                      </a:r>
                      <a:endParaRPr 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 (9)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 (11)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 (3)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 (10)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32211345"/>
                  </a:ext>
                </a:extLst>
              </a:tr>
              <a:tr h="719006"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rticobasal</a:t>
                      </a:r>
                      <a:r>
                        <a:rPr lang="en-US" sz="11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Degeneration (CBD)</a:t>
                      </a:r>
                      <a:endParaRPr 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  <a:r>
                        <a:rPr lang="en-US" sz="11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8)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</a:t>
                      </a:r>
                      <a:r>
                        <a:rPr lang="en-US" sz="11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9</a:t>
                      </a:r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2)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 (12)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36486815"/>
                  </a:ext>
                </a:extLst>
              </a:tr>
              <a:tr h="879261"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gressive </a:t>
                      </a:r>
                      <a:r>
                        <a:rPr lang="en-US" sz="11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pranuclear</a:t>
                      </a:r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alsy (PSP)</a:t>
                      </a:r>
                      <a:endParaRPr 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7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 (10)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 (9)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 (4)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 (6)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02177070"/>
                  </a:ext>
                </a:extLst>
              </a:tr>
              <a:tr h="579789"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ick’s Disease (Pick’s)</a:t>
                      </a:r>
                      <a:endParaRPr 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0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 (11)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 (7)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 (3)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 (8)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73459863"/>
                  </a:ext>
                </a:extLst>
              </a:tr>
              <a:tr h="558752"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  <a:endParaRPr lang="en-US" sz="11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sz="11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</a:t>
                      </a:r>
                      <a:endParaRPr lang="en-US" sz="11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r>
                        <a:rPr lang="en-US" sz="11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4)</a:t>
                      </a:r>
                      <a:endParaRPr lang="en-US" sz="11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/A</a:t>
                      </a:r>
                      <a:endParaRPr lang="en-US" sz="11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/A</a:t>
                      </a:r>
                      <a:endParaRPr lang="en-US" sz="11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 (12)</a:t>
                      </a:r>
                      <a:endParaRPr lang="en-US" sz="11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6066775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019413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3375</TotalTime>
  <Words>136</Words>
  <Application>Microsoft Office PowerPoint</Application>
  <PresentationFormat>Custom</PresentationFormat>
  <Paragraphs>4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Penn Medici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NDRUser</dc:creator>
  <cp:lastModifiedBy>Marshall, Courtney</cp:lastModifiedBy>
  <cp:revision>322</cp:revision>
  <cp:lastPrinted>2022-01-11T21:09:25Z</cp:lastPrinted>
  <dcterms:created xsi:type="dcterms:W3CDTF">2021-04-27T15:19:52Z</dcterms:created>
  <dcterms:modified xsi:type="dcterms:W3CDTF">2022-02-09T19:45:45Z</dcterms:modified>
</cp:coreProperties>
</file>